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55" r:id="rId2"/>
  </p:sldIdLst>
  <p:sldSz cx="12192000" cy="6858000"/>
  <p:notesSz cx="9923463" cy="67945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cientific Editor" initials="SE" lastIdx="9" clrIdx="0">
    <p:extLst>
      <p:ext uri="{19B8F6BF-5375-455C-9EA6-DF929625EA0E}">
        <p15:presenceInfo xmlns:p15="http://schemas.microsoft.com/office/powerpoint/2012/main" userId="Scientific Editor" providerId="None"/>
      </p:ext>
    </p:extLst>
  </p:cmAuthor>
  <p:cmAuthor id="2" name="takesue" initials="t" lastIdx="5" clrIdx="1">
    <p:extLst>
      <p:ext uri="{19B8F6BF-5375-455C-9EA6-DF929625EA0E}">
        <p15:presenceInfo xmlns:p15="http://schemas.microsoft.com/office/powerpoint/2012/main" userId="takesu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426" autoAdjust="0"/>
    <p:restoredTop sz="95529" autoAdjust="0"/>
  </p:normalViewPr>
  <p:slideViewPr>
    <p:cSldViewPr snapToGrid="0">
      <p:cViewPr varScale="1">
        <p:scale>
          <a:sx n="110" d="100"/>
          <a:sy n="110" d="100"/>
        </p:scale>
        <p:origin x="1044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0749" cy="341154"/>
          </a:xfrm>
          <a:prstGeom prst="rect">
            <a:avLst/>
          </a:prstGeom>
        </p:spPr>
        <p:txBody>
          <a:bodyPr vert="horz" lIns="91403" tIns="45702" rIns="91403" bIns="45702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1127" y="0"/>
            <a:ext cx="4300749" cy="341154"/>
          </a:xfrm>
          <a:prstGeom prst="rect">
            <a:avLst/>
          </a:prstGeom>
        </p:spPr>
        <p:txBody>
          <a:bodyPr vert="horz" lIns="91403" tIns="45702" rIns="91403" bIns="45702" rtlCol="0"/>
          <a:lstStyle>
            <a:lvl1pPr algn="r">
              <a:defRPr sz="1200"/>
            </a:lvl1pPr>
          </a:lstStyle>
          <a:p>
            <a:fld id="{EE51A95F-65DE-4144-A4F9-634112008E7B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924175" y="849313"/>
            <a:ext cx="4075113" cy="22923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03" tIns="45702" rIns="91403" bIns="45702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1871" y="3270310"/>
            <a:ext cx="7939722" cy="2675275"/>
          </a:xfrm>
          <a:prstGeom prst="rect">
            <a:avLst/>
          </a:prstGeom>
        </p:spPr>
        <p:txBody>
          <a:bodyPr vert="horz" lIns="91403" tIns="45702" rIns="91403" bIns="45702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453347"/>
            <a:ext cx="4300749" cy="341153"/>
          </a:xfrm>
          <a:prstGeom prst="rect">
            <a:avLst/>
          </a:prstGeom>
        </p:spPr>
        <p:txBody>
          <a:bodyPr vert="horz" lIns="91403" tIns="45702" rIns="91403" bIns="45702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1127" y="6453347"/>
            <a:ext cx="4300749" cy="341153"/>
          </a:xfrm>
          <a:prstGeom prst="rect">
            <a:avLst/>
          </a:prstGeom>
        </p:spPr>
        <p:txBody>
          <a:bodyPr vert="horz" lIns="91403" tIns="45702" rIns="91403" bIns="45702" rtlCol="0" anchor="b"/>
          <a:lstStyle>
            <a:lvl1pPr algn="r">
              <a:defRPr sz="1200"/>
            </a:lvl1pPr>
          </a:lstStyle>
          <a:p>
            <a:fld id="{E3776AED-F714-4E36-B15F-2F7F9B335F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08795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B805445-C5E7-8F3D-996C-AD90650695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C033B15-A4F8-6D06-28C0-1A2D4026D0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FC87F14-493E-DD58-B161-EC24192C32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0D18E99-8411-65B0-2E48-739DF1C67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733CEF5-EDC4-F417-EB78-DBB057DCE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96792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2698543-C304-D1F8-0D6B-FCEE756749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3D4BEDC-5958-8A32-4BEA-4DA0480924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3837EBE-E13E-9DBC-A607-854C2B8E80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EFEC844-3CE3-9E1D-561F-65256E043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64862CB-AE89-F53E-CBE6-C527B6EAF1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3486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4F8DADB-12FE-172E-9244-A8BB8E9919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AEABBDB-F138-6847-CA5E-7DA0EEDFE6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BFE7E1F-CA43-EFBF-947E-7C9267F867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80C432C-E29E-D3B8-AC56-E06F829D81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637A043-6A8F-6554-056F-723521569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4175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BDA391-41BC-8784-7F50-698A57A03A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3A5739D-C5BA-22E2-8E9D-19F595042A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B5F3F2A-9A84-A233-AFFF-DBD8EA2FA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B273A7-8C01-0B32-D927-A54EF51884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29BCC30-51BC-9E5D-64E0-C4186E67D6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11734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3F1CD6-FEC7-E737-0A7C-5654D4C489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AD5CB1A-09A0-9161-A4F9-739111FAE1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D679982-F495-7293-9420-80801866D5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ACDE3FD-03DF-33F6-1DE8-EADC8FA5CE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76B58B4-D4A8-D28F-7E00-2CE7DA7DCC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5567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57BC8D-CC93-E33B-79AE-AE2CAB14D0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80143E3-8DA8-1924-1FB4-70E81399409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CCBCFA5-4794-6D86-5232-F3142F5158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E349ED8-6BCD-343D-89CE-6CA4BDD8BC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B295D9E-3042-EBF9-590C-6D15DB1541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51B38AD-51DE-5A12-AB13-DA2E1E5A6B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6551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2AD5B5-0AA4-B54A-EDA9-C4F15B3F93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6A8EF41-E38C-25BA-18EB-2E978FF3E6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B557007-AEFF-29F5-5185-6F3687C24B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DF7C524-F2E7-4F44-4D91-41A1D72A65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580C3B5-1FC5-8827-E67A-7137A7D5CF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EBC0B17-37D0-6804-2642-F85E21268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86DB4C3-D99D-66C0-9B9B-7EA3BE8967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0B1387E-978A-9A80-E28C-E0F9DA3FEA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5786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3D41263-06DA-4F04-E1D6-77EDC95136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D4832DD-62AD-81AE-42D3-F0B25D3951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0E13C27-E914-7074-876C-16E94812D4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DAA2339-A053-13A5-6AD4-BAABA00700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3318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D530694-D296-03C8-F4D5-9DE351A669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C64E79D-6A5C-CA72-C94F-A3E2C1A157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DC5F7FD-D4BD-6C5B-5194-1AC3EB42B0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2750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7B202E-6E1B-BDF9-F7FF-9AA9328D8B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4529CAD-7770-44A5-00AB-2C3B356EF05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DD6EE63-BE28-B8D0-57AA-064197EAFF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AB4F50D-30FD-EA7E-FAC9-5E56B933B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FB0D5C2-601D-5FC0-FD06-9A6D0E8EB2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695EBB8-A87D-5FCB-95D4-897BD1E31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1787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25901B9-027C-8CF8-B66F-D01D5AE3F8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A623BA3-F2C7-E504-C748-B839E2523B9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A07837E-40DB-31B6-5C90-5B263A64C1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9B9F8B2-5AB9-899D-82E7-2F246515C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567CE2C-2F2C-11FE-EE36-C155014E75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35A3879-3D86-6ED3-0BAB-F98B80C0F8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5547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F2BFEDC-5E77-D0D7-D3FE-0DA0E0ECB0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756CCB6-60C8-67B7-381C-B0006635C9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742A2E9-A0C1-0081-604B-10C2D16DA7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7C0A2F7-0AAA-B474-9AF4-84E6FCE3F36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E183C30-2FBD-BC16-D0CC-FF7480F55E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58954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FAA06CB-972A-4D81-98C4-B6EADB499E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3333" y="31423"/>
            <a:ext cx="11345334" cy="461666"/>
          </a:xfrm>
        </p:spPr>
        <p:txBody>
          <a:bodyPr>
            <a:normAutofit/>
          </a:bodyPr>
          <a:lstStyle/>
          <a:p>
            <a:r>
              <a:rPr lang="hu-HU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comparison of patients’ days in each department between Hyogo</a:t>
            </a:r>
            <a:r>
              <a:rPr lang="hu-HU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ical University Hospital and </a:t>
            </a:r>
            <a:r>
              <a:rPr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koname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ity Hospital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コンテンツ プレースホルダー 3">
            <a:extLst>
              <a:ext uri="{FF2B5EF4-FFF2-40B4-BE49-F238E27FC236}">
                <a16:creationId xmlns:a16="http://schemas.microsoft.com/office/drawing/2014/main" id="{05E5B707-1DC7-4372-A534-282327166DFA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1001167" y="612550"/>
          <a:ext cx="8615833" cy="5575286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3517423">
                  <a:extLst>
                    <a:ext uri="{9D8B030D-6E8A-4147-A177-3AD203B41FA5}">
                      <a16:colId xmlns:a16="http://schemas.microsoft.com/office/drawing/2014/main" val="3281761591"/>
                    </a:ext>
                  </a:extLst>
                </a:gridCol>
                <a:gridCol w="3343401">
                  <a:extLst>
                    <a:ext uri="{9D8B030D-6E8A-4147-A177-3AD203B41FA5}">
                      <a16:colId xmlns:a16="http://schemas.microsoft.com/office/drawing/2014/main" val="1938988689"/>
                    </a:ext>
                  </a:extLst>
                </a:gridCol>
                <a:gridCol w="1755009">
                  <a:extLst>
                    <a:ext uri="{9D8B030D-6E8A-4147-A177-3AD203B41FA5}">
                      <a16:colId xmlns:a16="http://schemas.microsoft.com/office/drawing/2014/main" val="970731128"/>
                    </a:ext>
                  </a:extLst>
                </a:gridCol>
              </a:tblGrid>
              <a:tr h="12274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partment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tient days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63304183"/>
                  </a:ext>
                </a:extLst>
              </a:tr>
              <a:tr h="1440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ogo Medical University Hospital 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koname City Hospital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3507335119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stroenterolog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,667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81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1812570393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stroenterological surger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,279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1758375649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ral surger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94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1554036621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diovascular medicine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,043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85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337196620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matolog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,797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4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1975175892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ergy and rheumatolog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28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1181625121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betes,</a:t>
                      </a:r>
                      <a:r>
                        <a:rPr lang="en-US" sz="1050" u="none" strike="noStrike" baseline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abolism, and endocrinolog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57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2057845063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pirolog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,226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,267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3571522321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rolog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70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00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2653716637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phrology and artificial dialysis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32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58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4242198888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diatrics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18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1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826770712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ropsychiatr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42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3526857771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rmatolog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97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1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1504185656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east and endocrine surger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98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1720615080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diatric surger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7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365275749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oracic surger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61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2939412124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bstetrics and gynecolog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,581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1517457109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necolog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47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3558973369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thopedic surger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,361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,033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4238566409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stic and reconstructive surger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60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1932764562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rolog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57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4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3082323872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hthalmolog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08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8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1162530551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esthesiology and pain relief center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3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1610524859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ntistry and oral surger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22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0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2215131824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habilitation medicine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92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3495536664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mergency and critical care medicine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37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2078516453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orhinolaryngolog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45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8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2900955395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diovascular surger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83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1230531324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rosurger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,317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3535279025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diolog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3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148960999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onatal intensive care unit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28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4116001217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6,377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,033 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959" marR="3959" marT="3959" marB="0" anchor="ctr"/>
                </a:tc>
                <a:extLst>
                  <a:ext uri="{0D108BD9-81ED-4DB2-BD59-A6C34878D82A}">
                    <a16:rowId xmlns:a16="http://schemas.microsoft.com/office/drawing/2014/main" val="3943820530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F1392C8-C76E-4F04-A58B-033B233846CE}"/>
              </a:ext>
            </a:extLst>
          </p:cNvPr>
          <p:cNvSpPr txBox="1"/>
          <p:nvPr/>
        </p:nvSpPr>
        <p:spPr>
          <a:xfrm>
            <a:off x="617049" y="6307297"/>
            <a:ext cx="114689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 days in </a:t>
            </a:r>
            <a:r>
              <a:rPr lang="hu-HU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tensive care unit (ICU) admitted in each department was 3794 in the tertiary care hospital. No </a:t>
            </a:r>
            <a:r>
              <a:rPr lang="en-US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ICU is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sent in the community hospital.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8324517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30</TotalTime>
  <Words>198</Words>
  <Application>Microsoft Office PowerPoint</Application>
  <PresentationFormat>ワイド画面</PresentationFormat>
  <Paragraphs>10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S1 Table. The comparison of patients’ days in each department between Hyogo Medical University Hospital and Tokoname City Hospital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E_Mente</dc:creator>
  <cp:lastModifiedBy>植田貴史</cp:lastModifiedBy>
  <cp:revision>312</cp:revision>
  <cp:lastPrinted>2023-04-12T10:42:11Z</cp:lastPrinted>
  <dcterms:created xsi:type="dcterms:W3CDTF">2022-09-14T02:01:21Z</dcterms:created>
  <dcterms:modified xsi:type="dcterms:W3CDTF">2023-04-12T10:44:05Z</dcterms:modified>
</cp:coreProperties>
</file>